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8003838" cy="7923213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831E89-F31E-47CD-92E4-766DD203D07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900000" y="317160"/>
            <a:ext cx="16202160" cy="1320840"/>
          </a:xfrm>
          <a:prstGeom prst="rect">
            <a:avLst/>
          </a:prstGeom>
          <a:noFill/>
          <a:ln w="0">
            <a:noFill/>
          </a:ln>
        </p:spPr>
        <p:txBody>
          <a:bodyPr lIns="115560" rIns="115560" tIns="57600" bIns="57600" anchor="ctr">
            <a:noAutofit/>
          </a:bodyPr>
          <a:p>
            <a:pPr indent="0" algn="ctr">
              <a:buNone/>
              <a:tabLst>
                <a:tab algn="l" pos="0"/>
                <a:tab algn="l" pos="1154160"/>
                <a:tab algn="l" pos="2308320"/>
                <a:tab algn="l" pos="3462480"/>
                <a:tab algn="l" pos="4616280"/>
                <a:tab algn="l" pos="5770440"/>
                <a:tab algn="l" pos="6924600"/>
                <a:tab algn="l" pos="8078760"/>
                <a:tab algn="l" pos="9232920"/>
                <a:tab algn="l" pos="10387080"/>
              </a:tabLst>
            </a:pPr>
            <a:endParaRPr b="0" lang="en-US" sz="5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900000" y="1847880"/>
            <a:ext cx="16202160" cy="2494080"/>
          </a:xfrm>
          <a:prstGeom prst="rect">
            <a:avLst/>
          </a:prstGeom>
          <a:noFill/>
          <a:ln w="0">
            <a:noFill/>
          </a:ln>
        </p:spPr>
        <p:txBody>
          <a:bodyPr lIns="115560" rIns="115560" tIns="57600" bIns="57600" anchor="t">
            <a:normAutofit/>
          </a:bodyPr>
          <a:p>
            <a:pPr indent="0">
              <a:spcBef>
                <a:spcPts val="1001"/>
              </a:spcBef>
              <a:buNone/>
              <a:tabLst>
                <a:tab algn="l" pos="1154160"/>
                <a:tab algn="l" pos="2308320"/>
                <a:tab algn="l" pos="3462480"/>
                <a:tab algn="l" pos="4616280"/>
                <a:tab algn="l" pos="5770440"/>
                <a:tab algn="l" pos="6924600"/>
                <a:tab algn="l" pos="8078760"/>
                <a:tab algn="l" pos="9232920"/>
                <a:tab algn="l" pos="1038708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900000" y="4579200"/>
            <a:ext cx="16202160" cy="2494080"/>
          </a:xfrm>
          <a:prstGeom prst="rect">
            <a:avLst/>
          </a:prstGeom>
          <a:noFill/>
          <a:ln w="0">
            <a:noFill/>
          </a:ln>
        </p:spPr>
        <p:txBody>
          <a:bodyPr lIns="115560" rIns="115560" tIns="57600" bIns="57600" anchor="t">
            <a:normAutofit/>
          </a:bodyPr>
          <a:p>
            <a:pPr indent="0">
              <a:spcBef>
                <a:spcPts val="1001"/>
              </a:spcBef>
              <a:buNone/>
              <a:tabLst>
                <a:tab algn="l" pos="1154160"/>
                <a:tab algn="l" pos="2308320"/>
                <a:tab algn="l" pos="3462480"/>
                <a:tab algn="l" pos="4616280"/>
                <a:tab algn="l" pos="5770440"/>
                <a:tab algn="l" pos="6924600"/>
                <a:tab algn="l" pos="8078760"/>
                <a:tab algn="l" pos="9232920"/>
                <a:tab algn="l" pos="1038708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BD0BEA-42B0-4707-A93F-3C145587215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900000" y="317160"/>
            <a:ext cx="16202160" cy="1320840"/>
          </a:xfrm>
          <a:prstGeom prst="rect">
            <a:avLst/>
          </a:prstGeom>
          <a:noFill/>
          <a:ln w="0">
            <a:noFill/>
          </a:ln>
        </p:spPr>
        <p:txBody>
          <a:bodyPr lIns="115560" rIns="115560" tIns="57600" bIns="57600" anchor="ctr">
            <a:noAutofit/>
          </a:bodyPr>
          <a:p>
            <a:pPr indent="0" algn="ctr">
              <a:buNone/>
              <a:tabLst>
                <a:tab algn="l" pos="0"/>
                <a:tab algn="l" pos="1154160"/>
                <a:tab algn="l" pos="2308320"/>
                <a:tab algn="l" pos="3462480"/>
                <a:tab algn="l" pos="4616280"/>
                <a:tab algn="l" pos="5770440"/>
                <a:tab algn="l" pos="6924600"/>
                <a:tab algn="l" pos="8078760"/>
                <a:tab algn="l" pos="9232920"/>
                <a:tab algn="l" pos="10387080"/>
              </a:tabLst>
            </a:pPr>
            <a:endParaRPr b="0" lang="en-US" sz="5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900000" y="1847880"/>
            <a:ext cx="7906320" cy="2494080"/>
          </a:xfrm>
          <a:prstGeom prst="rect">
            <a:avLst/>
          </a:prstGeom>
          <a:noFill/>
          <a:ln w="0">
            <a:noFill/>
          </a:ln>
        </p:spPr>
        <p:txBody>
          <a:bodyPr lIns="115560" rIns="115560" tIns="57600" bIns="57600" anchor="t">
            <a:normAutofit/>
          </a:bodyPr>
          <a:p>
            <a:pPr indent="0">
              <a:spcBef>
                <a:spcPts val="1001"/>
              </a:spcBef>
              <a:buNone/>
              <a:tabLst>
                <a:tab algn="l" pos="1154160"/>
                <a:tab algn="l" pos="2308320"/>
                <a:tab algn="l" pos="3462480"/>
                <a:tab algn="l" pos="4616280"/>
                <a:tab algn="l" pos="5770440"/>
                <a:tab algn="l" pos="6924600"/>
                <a:tab algn="l" pos="8078760"/>
                <a:tab algn="l" pos="9232920"/>
                <a:tab algn="l" pos="1038708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9201960" y="1847880"/>
            <a:ext cx="7906320" cy="2494080"/>
          </a:xfrm>
          <a:prstGeom prst="rect">
            <a:avLst/>
          </a:prstGeom>
          <a:noFill/>
          <a:ln w="0">
            <a:noFill/>
          </a:ln>
        </p:spPr>
        <p:txBody>
          <a:bodyPr lIns="115560" rIns="115560" tIns="57600" bIns="57600" anchor="t">
            <a:normAutofit/>
          </a:bodyPr>
          <a:p>
            <a:pPr indent="0">
              <a:spcBef>
                <a:spcPts val="1001"/>
              </a:spcBef>
              <a:buNone/>
              <a:tabLst>
                <a:tab algn="l" pos="1154160"/>
                <a:tab algn="l" pos="2308320"/>
                <a:tab algn="l" pos="3462480"/>
                <a:tab algn="l" pos="4616280"/>
                <a:tab algn="l" pos="5770440"/>
                <a:tab algn="l" pos="6924600"/>
                <a:tab algn="l" pos="8078760"/>
                <a:tab algn="l" pos="9232920"/>
                <a:tab algn="l" pos="1038708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900000" y="4579200"/>
            <a:ext cx="7906320" cy="2494080"/>
          </a:xfrm>
          <a:prstGeom prst="rect">
            <a:avLst/>
          </a:prstGeom>
          <a:noFill/>
          <a:ln w="0">
            <a:noFill/>
          </a:ln>
        </p:spPr>
        <p:txBody>
          <a:bodyPr lIns="115560" rIns="115560" tIns="57600" bIns="57600" anchor="t">
            <a:normAutofit/>
          </a:bodyPr>
          <a:p>
            <a:pPr indent="0">
              <a:spcBef>
                <a:spcPts val="1001"/>
              </a:spcBef>
              <a:buNone/>
              <a:tabLst>
                <a:tab algn="l" pos="1154160"/>
                <a:tab algn="l" pos="2308320"/>
                <a:tab algn="l" pos="3462480"/>
                <a:tab algn="l" pos="4616280"/>
                <a:tab algn="l" pos="5770440"/>
                <a:tab algn="l" pos="6924600"/>
                <a:tab algn="l" pos="8078760"/>
                <a:tab algn="l" pos="9232920"/>
                <a:tab algn="l" pos="1038708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9201960" y="4579200"/>
            <a:ext cx="7906320" cy="2494080"/>
          </a:xfrm>
          <a:prstGeom prst="rect">
            <a:avLst/>
          </a:prstGeom>
          <a:noFill/>
          <a:ln w="0">
            <a:noFill/>
          </a:ln>
        </p:spPr>
        <p:txBody>
          <a:bodyPr lIns="115560" rIns="115560" tIns="57600" bIns="57600" anchor="t">
            <a:normAutofit/>
          </a:bodyPr>
          <a:p>
            <a:pPr indent="0">
              <a:spcBef>
                <a:spcPts val="1001"/>
              </a:spcBef>
              <a:buNone/>
              <a:tabLst>
                <a:tab algn="l" pos="1154160"/>
                <a:tab algn="l" pos="2308320"/>
                <a:tab algn="l" pos="3462480"/>
                <a:tab algn="l" pos="4616280"/>
                <a:tab algn="l" pos="5770440"/>
                <a:tab algn="l" pos="6924600"/>
                <a:tab algn="l" pos="8078760"/>
                <a:tab algn="l" pos="9232920"/>
                <a:tab algn="l" pos="1038708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B499C3-CBED-44C8-BCF5-7F62AD74551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900000" y="317160"/>
            <a:ext cx="16202160" cy="1320840"/>
          </a:xfrm>
          <a:prstGeom prst="rect">
            <a:avLst/>
          </a:prstGeom>
          <a:noFill/>
          <a:ln w="0">
            <a:noFill/>
          </a:ln>
        </p:spPr>
        <p:txBody>
          <a:bodyPr lIns="115560" rIns="115560" tIns="57600" bIns="57600" anchor="ctr">
            <a:noAutofit/>
          </a:bodyPr>
          <a:p>
            <a:pPr indent="0" algn="ctr">
              <a:buNone/>
              <a:tabLst>
                <a:tab algn="l" pos="0"/>
                <a:tab algn="l" pos="1154160"/>
                <a:tab algn="l" pos="2308320"/>
                <a:tab algn="l" pos="3462480"/>
                <a:tab algn="l" pos="4616280"/>
                <a:tab algn="l" pos="5770440"/>
                <a:tab algn="l" pos="6924600"/>
                <a:tab algn="l" pos="8078760"/>
                <a:tab algn="l" pos="9232920"/>
                <a:tab algn="l" pos="10387080"/>
              </a:tabLst>
            </a:pPr>
            <a:endParaRPr b="0" lang="en-US" sz="5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900000" y="1847880"/>
            <a:ext cx="5216760" cy="2494080"/>
          </a:xfrm>
          <a:prstGeom prst="rect">
            <a:avLst/>
          </a:prstGeom>
          <a:noFill/>
          <a:ln w="0">
            <a:noFill/>
          </a:ln>
        </p:spPr>
        <p:txBody>
          <a:bodyPr lIns="115560" rIns="115560" tIns="57600" bIns="57600" anchor="t">
            <a:normAutofit/>
          </a:bodyPr>
          <a:p>
            <a:pPr indent="0">
              <a:spcBef>
                <a:spcPts val="1001"/>
              </a:spcBef>
              <a:buNone/>
              <a:tabLst>
                <a:tab algn="l" pos="1154160"/>
                <a:tab algn="l" pos="2308320"/>
                <a:tab algn="l" pos="3462480"/>
                <a:tab algn="l" pos="4616280"/>
                <a:tab algn="l" pos="5770440"/>
                <a:tab algn="l" pos="6924600"/>
                <a:tab algn="l" pos="8078760"/>
                <a:tab algn="l" pos="9232920"/>
                <a:tab algn="l" pos="1038708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6378120" y="1847880"/>
            <a:ext cx="5216760" cy="2494080"/>
          </a:xfrm>
          <a:prstGeom prst="rect">
            <a:avLst/>
          </a:prstGeom>
          <a:noFill/>
          <a:ln w="0">
            <a:noFill/>
          </a:ln>
        </p:spPr>
        <p:txBody>
          <a:bodyPr lIns="115560" rIns="115560" tIns="57600" bIns="57600" anchor="t">
            <a:normAutofit/>
          </a:bodyPr>
          <a:p>
            <a:pPr indent="0">
              <a:spcBef>
                <a:spcPts val="1001"/>
              </a:spcBef>
              <a:buNone/>
              <a:tabLst>
                <a:tab algn="l" pos="1154160"/>
                <a:tab algn="l" pos="2308320"/>
                <a:tab algn="l" pos="3462480"/>
                <a:tab algn="l" pos="4616280"/>
                <a:tab algn="l" pos="5770440"/>
                <a:tab algn="l" pos="6924600"/>
                <a:tab algn="l" pos="8078760"/>
                <a:tab algn="l" pos="9232920"/>
                <a:tab algn="l" pos="1038708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11855880" y="1847880"/>
            <a:ext cx="5216760" cy="2494080"/>
          </a:xfrm>
          <a:prstGeom prst="rect">
            <a:avLst/>
          </a:prstGeom>
          <a:noFill/>
          <a:ln w="0">
            <a:noFill/>
          </a:ln>
        </p:spPr>
        <p:txBody>
          <a:bodyPr lIns="115560" rIns="115560" tIns="57600" bIns="57600" anchor="t">
            <a:normAutofit/>
          </a:bodyPr>
          <a:p>
            <a:pPr indent="0">
              <a:spcBef>
                <a:spcPts val="1001"/>
              </a:spcBef>
              <a:buNone/>
              <a:tabLst>
                <a:tab algn="l" pos="1154160"/>
                <a:tab algn="l" pos="2308320"/>
                <a:tab algn="l" pos="3462480"/>
                <a:tab algn="l" pos="4616280"/>
                <a:tab algn="l" pos="5770440"/>
                <a:tab algn="l" pos="6924600"/>
                <a:tab algn="l" pos="8078760"/>
                <a:tab algn="l" pos="9232920"/>
                <a:tab algn="l" pos="1038708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900000" y="4579200"/>
            <a:ext cx="5216760" cy="2494080"/>
          </a:xfrm>
          <a:prstGeom prst="rect">
            <a:avLst/>
          </a:prstGeom>
          <a:noFill/>
          <a:ln w="0">
            <a:noFill/>
          </a:ln>
        </p:spPr>
        <p:txBody>
          <a:bodyPr lIns="115560" rIns="115560" tIns="57600" bIns="57600" anchor="t">
            <a:normAutofit/>
          </a:bodyPr>
          <a:p>
            <a:pPr indent="0">
              <a:spcBef>
                <a:spcPts val="1001"/>
              </a:spcBef>
              <a:buNone/>
              <a:tabLst>
                <a:tab algn="l" pos="1154160"/>
                <a:tab algn="l" pos="2308320"/>
                <a:tab algn="l" pos="3462480"/>
                <a:tab algn="l" pos="4616280"/>
                <a:tab algn="l" pos="5770440"/>
                <a:tab algn="l" pos="6924600"/>
                <a:tab algn="l" pos="8078760"/>
                <a:tab algn="l" pos="9232920"/>
                <a:tab algn="l" pos="1038708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6378120" y="4579200"/>
            <a:ext cx="5216760" cy="2494080"/>
          </a:xfrm>
          <a:prstGeom prst="rect">
            <a:avLst/>
          </a:prstGeom>
          <a:noFill/>
          <a:ln w="0">
            <a:noFill/>
          </a:ln>
        </p:spPr>
        <p:txBody>
          <a:bodyPr lIns="115560" rIns="115560" tIns="57600" bIns="57600" anchor="t">
            <a:normAutofit/>
          </a:bodyPr>
          <a:p>
            <a:pPr indent="0">
              <a:spcBef>
                <a:spcPts val="1001"/>
              </a:spcBef>
              <a:buNone/>
              <a:tabLst>
                <a:tab algn="l" pos="1154160"/>
                <a:tab algn="l" pos="2308320"/>
                <a:tab algn="l" pos="3462480"/>
                <a:tab algn="l" pos="4616280"/>
                <a:tab algn="l" pos="5770440"/>
                <a:tab algn="l" pos="6924600"/>
                <a:tab algn="l" pos="8078760"/>
                <a:tab algn="l" pos="9232920"/>
                <a:tab algn="l" pos="1038708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11855880" y="4579200"/>
            <a:ext cx="5216760" cy="2494080"/>
          </a:xfrm>
          <a:prstGeom prst="rect">
            <a:avLst/>
          </a:prstGeom>
          <a:noFill/>
          <a:ln w="0">
            <a:noFill/>
          </a:ln>
        </p:spPr>
        <p:txBody>
          <a:bodyPr lIns="115560" rIns="115560" tIns="57600" bIns="57600" anchor="t">
            <a:normAutofit/>
          </a:bodyPr>
          <a:p>
            <a:pPr indent="0">
              <a:spcBef>
                <a:spcPts val="1001"/>
              </a:spcBef>
              <a:buNone/>
              <a:tabLst>
                <a:tab algn="l" pos="1154160"/>
                <a:tab algn="l" pos="2308320"/>
                <a:tab algn="l" pos="3462480"/>
                <a:tab algn="l" pos="4616280"/>
                <a:tab algn="l" pos="5770440"/>
                <a:tab algn="l" pos="6924600"/>
                <a:tab algn="l" pos="8078760"/>
                <a:tab algn="l" pos="9232920"/>
                <a:tab algn="l" pos="1038708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7AA144-9994-48EA-8949-0939DBB6075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900000" y="317160"/>
            <a:ext cx="16202160" cy="1320840"/>
          </a:xfrm>
          <a:prstGeom prst="rect">
            <a:avLst/>
          </a:prstGeom>
          <a:noFill/>
          <a:ln w="0">
            <a:noFill/>
          </a:ln>
        </p:spPr>
        <p:txBody>
          <a:bodyPr lIns="115560" rIns="115560" tIns="57600" bIns="57600" anchor="ctr">
            <a:noAutofit/>
          </a:bodyPr>
          <a:p>
            <a:pPr indent="0" algn="ctr">
              <a:buNone/>
              <a:tabLst>
                <a:tab algn="l" pos="0"/>
                <a:tab algn="l" pos="1154160"/>
                <a:tab algn="l" pos="2308320"/>
                <a:tab algn="l" pos="3462480"/>
                <a:tab algn="l" pos="4616280"/>
                <a:tab algn="l" pos="5770440"/>
                <a:tab algn="l" pos="6924600"/>
                <a:tab algn="l" pos="8078760"/>
                <a:tab algn="l" pos="9232920"/>
                <a:tab algn="l" pos="10387080"/>
              </a:tabLst>
            </a:pPr>
            <a:endParaRPr b="0" lang="en-US" sz="5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900000" y="1847880"/>
            <a:ext cx="16202160" cy="5229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1001"/>
              </a:spcBef>
              <a:buNone/>
              <a:tabLst>
                <a:tab algn="l" pos="0"/>
                <a:tab algn="l" pos="1154160"/>
                <a:tab algn="l" pos="2308320"/>
                <a:tab algn="l" pos="3462480"/>
                <a:tab algn="l" pos="4616280"/>
                <a:tab algn="l" pos="5770440"/>
                <a:tab algn="l" pos="6924600"/>
                <a:tab algn="l" pos="8078760"/>
                <a:tab algn="l" pos="9232920"/>
                <a:tab algn="l" pos="1038708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85A3F9-6EC9-423F-8FD1-6CFEABA72B7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900000" y="317160"/>
            <a:ext cx="16202160" cy="1320840"/>
          </a:xfrm>
          <a:prstGeom prst="rect">
            <a:avLst/>
          </a:prstGeom>
          <a:noFill/>
          <a:ln w="0">
            <a:noFill/>
          </a:ln>
        </p:spPr>
        <p:txBody>
          <a:bodyPr lIns="115560" rIns="115560" tIns="57600" bIns="57600" anchor="ctr">
            <a:noAutofit/>
          </a:bodyPr>
          <a:p>
            <a:pPr indent="0" algn="ctr">
              <a:buNone/>
              <a:tabLst>
                <a:tab algn="l" pos="0"/>
                <a:tab algn="l" pos="1154160"/>
                <a:tab algn="l" pos="2308320"/>
                <a:tab algn="l" pos="3462480"/>
                <a:tab algn="l" pos="4616280"/>
                <a:tab algn="l" pos="5770440"/>
                <a:tab algn="l" pos="6924600"/>
                <a:tab algn="l" pos="8078760"/>
                <a:tab algn="l" pos="9232920"/>
                <a:tab algn="l" pos="10387080"/>
              </a:tabLst>
            </a:pPr>
            <a:endParaRPr b="0" lang="en-US" sz="5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900000" y="1847880"/>
            <a:ext cx="16202160" cy="5229360"/>
          </a:xfrm>
          <a:prstGeom prst="rect">
            <a:avLst/>
          </a:prstGeom>
          <a:noFill/>
          <a:ln w="0">
            <a:noFill/>
          </a:ln>
        </p:spPr>
        <p:txBody>
          <a:bodyPr lIns="115560" rIns="115560" tIns="57600" bIns="57600" anchor="t">
            <a:normAutofit/>
          </a:bodyPr>
          <a:p>
            <a:pPr indent="0">
              <a:spcBef>
                <a:spcPts val="1001"/>
              </a:spcBef>
              <a:buNone/>
              <a:tabLst>
                <a:tab algn="l" pos="1154160"/>
                <a:tab algn="l" pos="2308320"/>
                <a:tab algn="l" pos="3462480"/>
                <a:tab algn="l" pos="4616280"/>
                <a:tab algn="l" pos="5770440"/>
                <a:tab algn="l" pos="6924600"/>
                <a:tab algn="l" pos="8078760"/>
                <a:tab algn="l" pos="9232920"/>
                <a:tab algn="l" pos="1038708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55FD76-9744-4713-8AF6-509D8394FAD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900000" y="317160"/>
            <a:ext cx="16202160" cy="1320840"/>
          </a:xfrm>
          <a:prstGeom prst="rect">
            <a:avLst/>
          </a:prstGeom>
          <a:noFill/>
          <a:ln w="0">
            <a:noFill/>
          </a:ln>
        </p:spPr>
        <p:txBody>
          <a:bodyPr lIns="115560" rIns="115560" tIns="57600" bIns="57600" anchor="ctr">
            <a:noAutofit/>
          </a:bodyPr>
          <a:p>
            <a:pPr indent="0" algn="ctr">
              <a:buNone/>
              <a:tabLst>
                <a:tab algn="l" pos="0"/>
                <a:tab algn="l" pos="1154160"/>
                <a:tab algn="l" pos="2308320"/>
                <a:tab algn="l" pos="3462480"/>
                <a:tab algn="l" pos="4616280"/>
                <a:tab algn="l" pos="5770440"/>
                <a:tab algn="l" pos="6924600"/>
                <a:tab algn="l" pos="8078760"/>
                <a:tab algn="l" pos="9232920"/>
                <a:tab algn="l" pos="10387080"/>
              </a:tabLst>
            </a:pPr>
            <a:endParaRPr b="0" lang="en-US" sz="5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900000" y="1847880"/>
            <a:ext cx="7906320" cy="5229360"/>
          </a:xfrm>
          <a:prstGeom prst="rect">
            <a:avLst/>
          </a:prstGeom>
          <a:noFill/>
          <a:ln w="0">
            <a:noFill/>
          </a:ln>
        </p:spPr>
        <p:txBody>
          <a:bodyPr lIns="115560" rIns="115560" tIns="57600" bIns="57600" anchor="t">
            <a:normAutofit/>
          </a:bodyPr>
          <a:p>
            <a:pPr indent="0">
              <a:spcBef>
                <a:spcPts val="1001"/>
              </a:spcBef>
              <a:buNone/>
              <a:tabLst>
                <a:tab algn="l" pos="1154160"/>
                <a:tab algn="l" pos="2308320"/>
                <a:tab algn="l" pos="3462480"/>
                <a:tab algn="l" pos="4616280"/>
                <a:tab algn="l" pos="5770440"/>
                <a:tab algn="l" pos="6924600"/>
                <a:tab algn="l" pos="8078760"/>
                <a:tab algn="l" pos="9232920"/>
                <a:tab algn="l" pos="1038708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9201960" y="1847880"/>
            <a:ext cx="7906320" cy="5229360"/>
          </a:xfrm>
          <a:prstGeom prst="rect">
            <a:avLst/>
          </a:prstGeom>
          <a:noFill/>
          <a:ln w="0">
            <a:noFill/>
          </a:ln>
        </p:spPr>
        <p:txBody>
          <a:bodyPr lIns="115560" rIns="115560" tIns="57600" bIns="57600" anchor="t">
            <a:normAutofit/>
          </a:bodyPr>
          <a:p>
            <a:pPr indent="0">
              <a:spcBef>
                <a:spcPts val="1001"/>
              </a:spcBef>
              <a:buNone/>
              <a:tabLst>
                <a:tab algn="l" pos="1154160"/>
                <a:tab algn="l" pos="2308320"/>
                <a:tab algn="l" pos="3462480"/>
                <a:tab algn="l" pos="4616280"/>
                <a:tab algn="l" pos="5770440"/>
                <a:tab algn="l" pos="6924600"/>
                <a:tab algn="l" pos="8078760"/>
                <a:tab algn="l" pos="9232920"/>
                <a:tab algn="l" pos="1038708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B3C6B9-C69C-496F-9C1F-5D04F604FA3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900000" y="317160"/>
            <a:ext cx="16202160" cy="1320840"/>
          </a:xfrm>
          <a:prstGeom prst="rect">
            <a:avLst/>
          </a:prstGeom>
          <a:noFill/>
          <a:ln w="0">
            <a:noFill/>
          </a:ln>
        </p:spPr>
        <p:txBody>
          <a:bodyPr lIns="115560" rIns="115560" tIns="57600" bIns="57600" anchor="ctr">
            <a:noAutofit/>
          </a:bodyPr>
          <a:p>
            <a:pPr indent="0" algn="ctr">
              <a:buNone/>
              <a:tabLst>
                <a:tab algn="l" pos="0"/>
                <a:tab algn="l" pos="1154160"/>
                <a:tab algn="l" pos="2308320"/>
                <a:tab algn="l" pos="3462480"/>
                <a:tab algn="l" pos="4616280"/>
                <a:tab algn="l" pos="5770440"/>
                <a:tab algn="l" pos="6924600"/>
                <a:tab algn="l" pos="8078760"/>
                <a:tab algn="l" pos="9232920"/>
                <a:tab algn="l" pos="10387080"/>
              </a:tabLst>
            </a:pPr>
            <a:endParaRPr b="0" lang="en-US" sz="5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691DD1-FAC1-4898-8DAA-D3EB12EEE5B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900000" y="317160"/>
            <a:ext cx="16202160" cy="612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1001"/>
              </a:spcBef>
              <a:tabLst>
                <a:tab algn="l" pos="0"/>
                <a:tab algn="l" pos="1154160"/>
                <a:tab algn="l" pos="2308320"/>
                <a:tab algn="l" pos="3462480"/>
                <a:tab algn="l" pos="4616280"/>
                <a:tab algn="l" pos="5770440"/>
                <a:tab algn="l" pos="6924600"/>
                <a:tab algn="l" pos="8078760"/>
                <a:tab algn="l" pos="9232920"/>
                <a:tab algn="l" pos="1038708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943191-39B1-49E8-AAFD-95EAE01F5F6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900000" y="317160"/>
            <a:ext cx="16202160" cy="1320840"/>
          </a:xfrm>
          <a:prstGeom prst="rect">
            <a:avLst/>
          </a:prstGeom>
          <a:noFill/>
          <a:ln w="0">
            <a:noFill/>
          </a:ln>
        </p:spPr>
        <p:txBody>
          <a:bodyPr lIns="115560" rIns="115560" tIns="57600" bIns="57600" anchor="ctr">
            <a:noAutofit/>
          </a:bodyPr>
          <a:p>
            <a:pPr indent="0" algn="ctr">
              <a:buNone/>
              <a:tabLst>
                <a:tab algn="l" pos="0"/>
                <a:tab algn="l" pos="1154160"/>
                <a:tab algn="l" pos="2308320"/>
                <a:tab algn="l" pos="3462480"/>
                <a:tab algn="l" pos="4616280"/>
                <a:tab algn="l" pos="5770440"/>
                <a:tab algn="l" pos="6924600"/>
                <a:tab algn="l" pos="8078760"/>
                <a:tab algn="l" pos="9232920"/>
                <a:tab algn="l" pos="10387080"/>
              </a:tabLst>
            </a:pPr>
            <a:endParaRPr b="0" lang="en-US" sz="5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900000" y="1847880"/>
            <a:ext cx="7906320" cy="2494080"/>
          </a:xfrm>
          <a:prstGeom prst="rect">
            <a:avLst/>
          </a:prstGeom>
          <a:noFill/>
          <a:ln w="0">
            <a:noFill/>
          </a:ln>
        </p:spPr>
        <p:txBody>
          <a:bodyPr lIns="115560" rIns="115560" tIns="57600" bIns="57600" anchor="t">
            <a:normAutofit/>
          </a:bodyPr>
          <a:p>
            <a:pPr indent="0">
              <a:spcBef>
                <a:spcPts val="1001"/>
              </a:spcBef>
              <a:buNone/>
              <a:tabLst>
                <a:tab algn="l" pos="1154160"/>
                <a:tab algn="l" pos="2308320"/>
                <a:tab algn="l" pos="3462480"/>
                <a:tab algn="l" pos="4616280"/>
                <a:tab algn="l" pos="5770440"/>
                <a:tab algn="l" pos="6924600"/>
                <a:tab algn="l" pos="8078760"/>
                <a:tab algn="l" pos="9232920"/>
                <a:tab algn="l" pos="1038708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9201960" y="1847880"/>
            <a:ext cx="7906320" cy="5229360"/>
          </a:xfrm>
          <a:prstGeom prst="rect">
            <a:avLst/>
          </a:prstGeom>
          <a:noFill/>
          <a:ln w="0">
            <a:noFill/>
          </a:ln>
        </p:spPr>
        <p:txBody>
          <a:bodyPr lIns="115560" rIns="115560" tIns="57600" bIns="57600" anchor="t">
            <a:normAutofit/>
          </a:bodyPr>
          <a:p>
            <a:pPr indent="0">
              <a:spcBef>
                <a:spcPts val="1001"/>
              </a:spcBef>
              <a:buNone/>
              <a:tabLst>
                <a:tab algn="l" pos="1154160"/>
                <a:tab algn="l" pos="2308320"/>
                <a:tab algn="l" pos="3462480"/>
                <a:tab algn="l" pos="4616280"/>
                <a:tab algn="l" pos="5770440"/>
                <a:tab algn="l" pos="6924600"/>
                <a:tab algn="l" pos="8078760"/>
                <a:tab algn="l" pos="9232920"/>
                <a:tab algn="l" pos="1038708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900000" y="4579200"/>
            <a:ext cx="7906320" cy="2494080"/>
          </a:xfrm>
          <a:prstGeom prst="rect">
            <a:avLst/>
          </a:prstGeom>
          <a:noFill/>
          <a:ln w="0">
            <a:noFill/>
          </a:ln>
        </p:spPr>
        <p:txBody>
          <a:bodyPr lIns="115560" rIns="115560" tIns="57600" bIns="57600" anchor="t">
            <a:normAutofit/>
          </a:bodyPr>
          <a:p>
            <a:pPr indent="0">
              <a:spcBef>
                <a:spcPts val="1001"/>
              </a:spcBef>
              <a:buNone/>
              <a:tabLst>
                <a:tab algn="l" pos="1154160"/>
                <a:tab algn="l" pos="2308320"/>
                <a:tab algn="l" pos="3462480"/>
                <a:tab algn="l" pos="4616280"/>
                <a:tab algn="l" pos="5770440"/>
                <a:tab algn="l" pos="6924600"/>
                <a:tab algn="l" pos="8078760"/>
                <a:tab algn="l" pos="9232920"/>
                <a:tab algn="l" pos="1038708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F1385F-2B9A-4370-9513-F9A028D1DE1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900000" y="317160"/>
            <a:ext cx="16202160" cy="1320840"/>
          </a:xfrm>
          <a:prstGeom prst="rect">
            <a:avLst/>
          </a:prstGeom>
          <a:noFill/>
          <a:ln w="0">
            <a:noFill/>
          </a:ln>
        </p:spPr>
        <p:txBody>
          <a:bodyPr lIns="115560" rIns="115560" tIns="57600" bIns="57600" anchor="ctr">
            <a:noAutofit/>
          </a:bodyPr>
          <a:p>
            <a:pPr indent="0" algn="ctr">
              <a:buNone/>
              <a:tabLst>
                <a:tab algn="l" pos="0"/>
                <a:tab algn="l" pos="1154160"/>
                <a:tab algn="l" pos="2308320"/>
                <a:tab algn="l" pos="3462480"/>
                <a:tab algn="l" pos="4616280"/>
                <a:tab algn="l" pos="5770440"/>
                <a:tab algn="l" pos="6924600"/>
                <a:tab algn="l" pos="8078760"/>
                <a:tab algn="l" pos="9232920"/>
                <a:tab algn="l" pos="10387080"/>
              </a:tabLst>
            </a:pPr>
            <a:endParaRPr b="0" lang="en-US" sz="5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900000" y="1847880"/>
            <a:ext cx="7906320" cy="5229360"/>
          </a:xfrm>
          <a:prstGeom prst="rect">
            <a:avLst/>
          </a:prstGeom>
          <a:noFill/>
          <a:ln w="0">
            <a:noFill/>
          </a:ln>
        </p:spPr>
        <p:txBody>
          <a:bodyPr lIns="115560" rIns="115560" tIns="57600" bIns="57600" anchor="t">
            <a:normAutofit/>
          </a:bodyPr>
          <a:p>
            <a:pPr indent="0">
              <a:spcBef>
                <a:spcPts val="1001"/>
              </a:spcBef>
              <a:buNone/>
              <a:tabLst>
                <a:tab algn="l" pos="1154160"/>
                <a:tab algn="l" pos="2308320"/>
                <a:tab algn="l" pos="3462480"/>
                <a:tab algn="l" pos="4616280"/>
                <a:tab algn="l" pos="5770440"/>
                <a:tab algn="l" pos="6924600"/>
                <a:tab algn="l" pos="8078760"/>
                <a:tab algn="l" pos="9232920"/>
                <a:tab algn="l" pos="1038708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9201960" y="1847880"/>
            <a:ext cx="7906320" cy="2494080"/>
          </a:xfrm>
          <a:prstGeom prst="rect">
            <a:avLst/>
          </a:prstGeom>
          <a:noFill/>
          <a:ln w="0">
            <a:noFill/>
          </a:ln>
        </p:spPr>
        <p:txBody>
          <a:bodyPr lIns="115560" rIns="115560" tIns="57600" bIns="57600" anchor="t">
            <a:normAutofit/>
          </a:bodyPr>
          <a:p>
            <a:pPr indent="0">
              <a:spcBef>
                <a:spcPts val="1001"/>
              </a:spcBef>
              <a:buNone/>
              <a:tabLst>
                <a:tab algn="l" pos="1154160"/>
                <a:tab algn="l" pos="2308320"/>
                <a:tab algn="l" pos="3462480"/>
                <a:tab algn="l" pos="4616280"/>
                <a:tab algn="l" pos="5770440"/>
                <a:tab algn="l" pos="6924600"/>
                <a:tab algn="l" pos="8078760"/>
                <a:tab algn="l" pos="9232920"/>
                <a:tab algn="l" pos="1038708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9201960" y="4579200"/>
            <a:ext cx="7906320" cy="2494080"/>
          </a:xfrm>
          <a:prstGeom prst="rect">
            <a:avLst/>
          </a:prstGeom>
          <a:noFill/>
          <a:ln w="0">
            <a:noFill/>
          </a:ln>
        </p:spPr>
        <p:txBody>
          <a:bodyPr lIns="115560" rIns="115560" tIns="57600" bIns="57600" anchor="t">
            <a:normAutofit/>
          </a:bodyPr>
          <a:p>
            <a:pPr indent="0">
              <a:spcBef>
                <a:spcPts val="1001"/>
              </a:spcBef>
              <a:buNone/>
              <a:tabLst>
                <a:tab algn="l" pos="1154160"/>
                <a:tab algn="l" pos="2308320"/>
                <a:tab algn="l" pos="3462480"/>
                <a:tab algn="l" pos="4616280"/>
                <a:tab algn="l" pos="5770440"/>
                <a:tab algn="l" pos="6924600"/>
                <a:tab algn="l" pos="8078760"/>
                <a:tab algn="l" pos="9232920"/>
                <a:tab algn="l" pos="1038708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B28EBC-5BBA-491A-8006-A2D4C7C4319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900000" y="317160"/>
            <a:ext cx="16202160" cy="1320840"/>
          </a:xfrm>
          <a:prstGeom prst="rect">
            <a:avLst/>
          </a:prstGeom>
          <a:noFill/>
          <a:ln w="0">
            <a:noFill/>
          </a:ln>
        </p:spPr>
        <p:txBody>
          <a:bodyPr lIns="115560" rIns="115560" tIns="57600" bIns="57600" anchor="ctr">
            <a:noAutofit/>
          </a:bodyPr>
          <a:p>
            <a:pPr indent="0" algn="ctr">
              <a:buNone/>
              <a:tabLst>
                <a:tab algn="l" pos="0"/>
                <a:tab algn="l" pos="1154160"/>
                <a:tab algn="l" pos="2308320"/>
                <a:tab algn="l" pos="3462480"/>
                <a:tab algn="l" pos="4616280"/>
                <a:tab algn="l" pos="5770440"/>
                <a:tab algn="l" pos="6924600"/>
                <a:tab algn="l" pos="8078760"/>
                <a:tab algn="l" pos="9232920"/>
                <a:tab algn="l" pos="10387080"/>
              </a:tabLst>
            </a:pPr>
            <a:endParaRPr b="0" lang="en-US" sz="5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900000" y="1847880"/>
            <a:ext cx="7906320" cy="2494080"/>
          </a:xfrm>
          <a:prstGeom prst="rect">
            <a:avLst/>
          </a:prstGeom>
          <a:noFill/>
          <a:ln w="0">
            <a:noFill/>
          </a:ln>
        </p:spPr>
        <p:txBody>
          <a:bodyPr lIns="115560" rIns="115560" tIns="57600" bIns="57600" anchor="t">
            <a:normAutofit/>
          </a:bodyPr>
          <a:p>
            <a:pPr indent="0">
              <a:spcBef>
                <a:spcPts val="1001"/>
              </a:spcBef>
              <a:buNone/>
              <a:tabLst>
                <a:tab algn="l" pos="1154160"/>
                <a:tab algn="l" pos="2308320"/>
                <a:tab algn="l" pos="3462480"/>
                <a:tab algn="l" pos="4616280"/>
                <a:tab algn="l" pos="5770440"/>
                <a:tab algn="l" pos="6924600"/>
                <a:tab algn="l" pos="8078760"/>
                <a:tab algn="l" pos="9232920"/>
                <a:tab algn="l" pos="1038708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9201960" y="1847880"/>
            <a:ext cx="7906320" cy="2494080"/>
          </a:xfrm>
          <a:prstGeom prst="rect">
            <a:avLst/>
          </a:prstGeom>
          <a:noFill/>
          <a:ln w="0">
            <a:noFill/>
          </a:ln>
        </p:spPr>
        <p:txBody>
          <a:bodyPr lIns="115560" rIns="115560" tIns="57600" bIns="57600" anchor="t">
            <a:normAutofit/>
          </a:bodyPr>
          <a:p>
            <a:pPr indent="0">
              <a:spcBef>
                <a:spcPts val="1001"/>
              </a:spcBef>
              <a:buNone/>
              <a:tabLst>
                <a:tab algn="l" pos="1154160"/>
                <a:tab algn="l" pos="2308320"/>
                <a:tab algn="l" pos="3462480"/>
                <a:tab algn="l" pos="4616280"/>
                <a:tab algn="l" pos="5770440"/>
                <a:tab algn="l" pos="6924600"/>
                <a:tab algn="l" pos="8078760"/>
                <a:tab algn="l" pos="9232920"/>
                <a:tab algn="l" pos="1038708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900000" y="4579200"/>
            <a:ext cx="16202160" cy="2494080"/>
          </a:xfrm>
          <a:prstGeom prst="rect">
            <a:avLst/>
          </a:prstGeom>
          <a:noFill/>
          <a:ln w="0">
            <a:noFill/>
          </a:ln>
        </p:spPr>
        <p:txBody>
          <a:bodyPr lIns="115560" rIns="115560" tIns="57600" bIns="57600" anchor="t">
            <a:normAutofit/>
          </a:bodyPr>
          <a:p>
            <a:pPr indent="0">
              <a:spcBef>
                <a:spcPts val="1001"/>
              </a:spcBef>
              <a:buNone/>
              <a:tabLst>
                <a:tab algn="l" pos="1154160"/>
                <a:tab algn="l" pos="2308320"/>
                <a:tab algn="l" pos="3462480"/>
                <a:tab algn="l" pos="4616280"/>
                <a:tab algn="l" pos="5770440"/>
                <a:tab algn="l" pos="6924600"/>
                <a:tab algn="l" pos="8078760"/>
                <a:tab algn="l" pos="9232920"/>
                <a:tab algn="l" pos="1038708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6D9CD2-7CD3-4BFF-B473-633D4FBEE5E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900000" y="317160"/>
            <a:ext cx="16202160" cy="1320840"/>
          </a:xfrm>
          <a:prstGeom prst="rect">
            <a:avLst/>
          </a:prstGeom>
          <a:noFill/>
          <a:ln w="0">
            <a:noFill/>
          </a:ln>
        </p:spPr>
        <p:txBody>
          <a:bodyPr lIns="115560" rIns="115560" tIns="57600" bIns="57600" anchor="ctr">
            <a:noAutofit/>
          </a:bodyPr>
          <a:p>
            <a:pPr indent="0" algn="ctr">
              <a:buNone/>
              <a:tabLst>
                <a:tab algn="l" pos="0"/>
                <a:tab algn="l" pos="1154160"/>
                <a:tab algn="l" pos="2308320"/>
                <a:tab algn="l" pos="3462480"/>
                <a:tab algn="l" pos="4616280"/>
                <a:tab algn="l" pos="5770440"/>
                <a:tab algn="l" pos="6924600"/>
                <a:tab algn="l" pos="8078760"/>
                <a:tab algn="l" pos="9232920"/>
                <a:tab algn="l" pos="10387080"/>
              </a:tabLst>
            </a:pPr>
            <a:r>
              <a:rPr b="0" lang="en-US" sz="56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5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900000" y="1847880"/>
            <a:ext cx="16202160" cy="5229360"/>
          </a:xfrm>
          <a:prstGeom prst="rect">
            <a:avLst/>
          </a:prstGeom>
          <a:noFill/>
          <a:ln w="0">
            <a:noFill/>
          </a:ln>
        </p:spPr>
        <p:txBody>
          <a:bodyPr lIns="115560" rIns="115560" tIns="57600" bIns="57600" anchor="t">
            <a:normAutofit/>
          </a:bodyPr>
          <a:p>
            <a:pPr marL="433440" indent="-433440"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1154160"/>
                <a:tab algn="l" pos="2308320"/>
                <a:tab algn="l" pos="3462480"/>
                <a:tab algn="l" pos="4616280"/>
                <a:tab algn="l" pos="5770440"/>
                <a:tab algn="l" pos="6924600"/>
                <a:tab algn="l" pos="8078760"/>
                <a:tab algn="l" pos="9232920"/>
                <a:tab algn="l" pos="1038708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 lvl="1" marL="938160" indent="-360360">
              <a:spcBef>
                <a:spcPts val="1001"/>
              </a:spcBef>
              <a:buClr>
                <a:srgbClr val="000000"/>
              </a:buClr>
              <a:buFont typeface="Arial"/>
              <a:buChar char="–"/>
              <a:tabLst>
                <a:tab algn="l" pos="1154160"/>
                <a:tab algn="l" pos="2308320"/>
                <a:tab algn="l" pos="3462480"/>
                <a:tab algn="l" pos="4616280"/>
                <a:tab algn="l" pos="5770440"/>
                <a:tab algn="l" pos="6924600"/>
                <a:tab algn="l" pos="8078760"/>
                <a:tab algn="l" pos="9232920"/>
                <a:tab algn="l" pos="1038708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 lvl="2" marL="1442880" indent="-288720"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1154160"/>
                <a:tab algn="l" pos="2308320"/>
                <a:tab algn="l" pos="3462480"/>
                <a:tab algn="l" pos="4616280"/>
                <a:tab algn="l" pos="5770440"/>
                <a:tab algn="l" pos="6924600"/>
                <a:tab algn="l" pos="8078760"/>
                <a:tab algn="l" pos="9232920"/>
                <a:tab algn="l" pos="1038708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 lvl="3" marL="2021040" indent="-289080">
              <a:spcBef>
                <a:spcPts val="1001"/>
              </a:spcBef>
              <a:buClr>
                <a:srgbClr val="000000"/>
              </a:buClr>
              <a:buFont typeface="Arial"/>
              <a:buChar char="–"/>
              <a:tabLst>
                <a:tab algn="l" pos="1154160"/>
                <a:tab algn="l" pos="2308320"/>
                <a:tab algn="l" pos="3462480"/>
                <a:tab algn="l" pos="4616280"/>
                <a:tab algn="l" pos="5770440"/>
                <a:tab algn="l" pos="6924600"/>
                <a:tab algn="l" pos="8078760"/>
                <a:tab algn="l" pos="9232920"/>
                <a:tab algn="l" pos="1038708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 lvl="4" marL="2598840" indent="-289080">
              <a:spcBef>
                <a:spcPts val="1001"/>
              </a:spcBef>
              <a:buClr>
                <a:srgbClr val="000000"/>
              </a:buClr>
              <a:buFont typeface="Arial"/>
              <a:buChar char="»"/>
              <a:tabLst>
                <a:tab algn="l" pos="1154160"/>
                <a:tab algn="l" pos="2308320"/>
                <a:tab algn="l" pos="3462480"/>
                <a:tab algn="l" pos="4616280"/>
                <a:tab algn="l" pos="5770440"/>
                <a:tab algn="l" pos="6924600"/>
                <a:tab algn="l" pos="8078760"/>
                <a:tab algn="l" pos="9232920"/>
                <a:tab algn="l" pos="1038708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 lvl="5" marL="2598840" indent="-289080">
              <a:spcBef>
                <a:spcPts val="1001"/>
              </a:spcBef>
              <a:buClr>
                <a:srgbClr val="000000"/>
              </a:buClr>
              <a:buFont typeface="Arial"/>
              <a:buChar char="»"/>
              <a:tabLst>
                <a:tab algn="l" pos="1154160"/>
                <a:tab algn="l" pos="2308320"/>
                <a:tab algn="l" pos="3462480"/>
                <a:tab algn="l" pos="4616280"/>
                <a:tab algn="l" pos="5770440"/>
                <a:tab algn="l" pos="6924600"/>
                <a:tab algn="l" pos="8078760"/>
                <a:tab algn="l" pos="9232920"/>
                <a:tab algn="l" pos="1038708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 lvl="6" marL="2598840" indent="-289080">
              <a:spcBef>
                <a:spcPts val="1001"/>
              </a:spcBef>
              <a:buClr>
                <a:srgbClr val="000000"/>
              </a:buClr>
              <a:buFont typeface="Arial"/>
              <a:buChar char="»"/>
              <a:tabLst>
                <a:tab algn="l" pos="1154160"/>
                <a:tab algn="l" pos="2308320"/>
                <a:tab algn="l" pos="3462480"/>
                <a:tab algn="l" pos="4616280"/>
                <a:tab algn="l" pos="5770440"/>
                <a:tab algn="l" pos="6924600"/>
                <a:tab algn="l" pos="8078760"/>
                <a:tab algn="l" pos="9232920"/>
                <a:tab algn="l" pos="1038708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900000" y="7213680"/>
            <a:ext cx="4200480" cy="550800"/>
          </a:xfrm>
          <a:prstGeom prst="rect">
            <a:avLst/>
          </a:prstGeom>
          <a:noFill/>
          <a:ln w="0">
            <a:noFill/>
          </a:ln>
        </p:spPr>
        <p:txBody>
          <a:bodyPr lIns="115560" rIns="115560" tIns="57600" bIns="576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6149880" y="7213680"/>
            <a:ext cx="5702400" cy="550800"/>
          </a:xfrm>
          <a:prstGeom prst="rect">
            <a:avLst/>
          </a:prstGeom>
          <a:noFill/>
          <a:ln w="0">
            <a:noFill/>
          </a:ln>
        </p:spPr>
        <p:txBody>
          <a:bodyPr lIns="115560" rIns="115560" tIns="57600" bIns="576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12901680" y="7213680"/>
            <a:ext cx="4200480" cy="550800"/>
          </a:xfrm>
          <a:prstGeom prst="rect">
            <a:avLst/>
          </a:prstGeom>
          <a:noFill/>
          <a:ln w="0">
            <a:noFill/>
          </a:ln>
        </p:spPr>
        <p:txBody>
          <a:bodyPr lIns="115560" rIns="115560" tIns="57600" bIns="576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8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57FF142-DE1F-433A-A4C9-AEF284570FC5}" type="slidenum">
              <a:rPr b="0" lang="en-US" sz="18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32"/>
          <p:cNvGrpSpPr/>
          <p:nvPr/>
        </p:nvGrpSpPr>
        <p:grpSpPr>
          <a:xfrm>
            <a:off x="1046160" y="376200"/>
            <a:ext cx="16308360" cy="7162560"/>
            <a:chOff x="1046160" y="376200"/>
            <a:chExt cx="16308360" cy="7162560"/>
          </a:xfrm>
        </p:grpSpPr>
        <p:grpSp>
          <p:nvGrpSpPr>
            <p:cNvPr id="42" name="Group 43"/>
            <p:cNvGrpSpPr/>
            <p:nvPr/>
          </p:nvGrpSpPr>
          <p:grpSpPr>
            <a:xfrm>
              <a:off x="1046160" y="376200"/>
              <a:ext cx="16308360" cy="7162560"/>
              <a:chOff x="1046160" y="376200"/>
              <a:chExt cx="16308360" cy="7162560"/>
            </a:xfrm>
          </p:grpSpPr>
          <p:sp>
            <p:nvSpPr>
              <p:cNvPr id="43" name="Rectangle 36"/>
              <p:cNvSpPr/>
              <p:nvPr/>
            </p:nvSpPr>
            <p:spPr>
              <a:xfrm rot="5400000">
                <a:off x="10333440" y="-5348880"/>
                <a:ext cx="379440" cy="12668040"/>
              </a:xfrm>
              <a:prstGeom prst="rect">
                <a:avLst/>
              </a:prstGeom>
              <a:solidFill>
                <a:srgbClr val="eaeaea">
                  <a:alpha val="50000"/>
                </a:srgbClr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 anchorCtr="1" vert="eaVert" rot="10800000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" name="Rectangle 37"/>
              <p:cNvSpPr/>
              <p:nvPr/>
            </p:nvSpPr>
            <p:spPr>
              <a:xfrm rot="5400000">
                <a:off x="10111680" y="-4860360"/>
                <a:ext cx="379440" cy="13112640"/>
              </a:xfrm>
              <a:prstGeom prst="rect">
                <a:avLst/>
              </a:prstGeom>
              <a:solidFill>
                <a:srgbClr val="eaeaea">
                  <a:alpha val="50000"/>
                </a:srgbClr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 anchorCtr="1" vert="eaVert" rot="10800000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Rectangle 38"/>
              <p:cNvSpPr/>
              <p:nvPr/>
            </p:nvSpPr>
            <p:spPr>
              <a:xfrm rot="5400000">
                <a:off x="9996840" y="-4244040"/>
                <a:ext cx="379440" cy="13341240"/>
              </a:xfrm>
              <a:prstGeom prst="rect">
                <a:avLst/>
              </a:prstGeom>
              <a:solidFill>
                <a:srgbClr val="eaeaea">
                  <a:alpha val="50000"/>
                </a:srgbClr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 anchorCtr="1" vert="eaVert" rot="10800000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Rectangle 39"/>
              <p:cNvSpPr/>
              <p:nvPr/>
            </p:nvSpPr>
            <p:spPr>
              <a:xfrm rot="5400000">
                <a:off x="10047600" y="-3463200"/>
                <a:ext cx="379440" cy="13239720"/>
              </a:xfrm>
              <a:prstGeom prst="rect">
                <a:avLst/>
              </a:prstGeom>
              <a:solidFill>
                <a:srgbClr val="eaeaea">
                  <a:alpha val="50000"/>
                </a:srgbClr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 anchorCtr="1" vert="eaVert" rot="10800000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Rectangle 40"/>
              <p:cNvSpPr/>
              <p:nvPr/>
            </p:nvSpPr>
            <p:spPr>
              <a:xfrm rot="5400000">
                <a:off x="9832320" y="-2986920"/>
                <a:ext cx="379440" cy="13671360"/>
              </a:xfrm>
              <a:prstGeom prst="rect">
                <a:avLst/>
              </a:prstGeom>
              <a:solidFill>
                <a:srgbClr val="eaeaea">
                  <a:alpha val="50000"/>
                </a:srgbClr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 anchorCtr="1" vert="eaVert" rot="10800000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Rectangle 41"/>
              <p:cNvSpPr/>
              <p:nvPr/>
            </p:nvSpPr>
            <p:spPr>
              <a:xfrm rot="5400000">
                <a:off x="9832320" y="-2275920"/>
                <a:ext cx="379440" cy="13671360"/>
              </a:xfrm>
              <a:prstGeom prst="rect">
                <a:avLst/>
              </a:prstGeom>
              <a:solidFill>
                <a:srgbClr val="eaeaea">
                  <a:alpha val="50000"/>
                </a:srgbClr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 anchorCtr="1" vert="eaVert" rot="10800000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Rectangle 28"/>
              <p:cNvSpPr/>
              <p:nvPr/>
            </p:nvSpPr>
            <p:spPr>
              <a:xfrm>
                <a:off x="6756480" y="379080"/>
                <a:ext cx="758880" cy="6977160"/>
              </a:xfrm>
              <a:prstGeom prst="rect">
                <a:avLst/>
              </a:prstGeom>
              <a:solidFill>
                <a:srgbClr val="eaeaea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Rectangle 29"/>
              <p:cNvSpPr/>
              <p:nvPr/>
            </p:nvSpPr>
            <p:spPr>
              <a:xfrm>
                <a:off x="8456760" y="376200"/>
                <a:ext cx="758880" cy="6986520"/>
              </a:xfrm>
              <a:prstGeom prst="rect">
                <a:avLst/>
              </a:prstGeom>
              <a:solidFill>
                <a:srgbClr val="eaeaea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Rectangle 30"/>
              <p:cNvSpPr/>
              <p:nvPr/>
            </p:nvSpPr>
            <p:spPr>
              <a:xfrm>
                <a:off x="10114200" y="376200"/>
                <a:ext cx="758880" cy="6989760"/>
              </a:xfrm>
              <a:prstGeom prst="rect">
                <a:avLst/>
              </a:prstGeom>
              <a:solidFill>
                <a:srgbClr val="eaeaea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Rectangle 31"/>
              <p:cNvSpPr/>
              <p:nvPr/>
            </p:nvSpPr>
            <p:spPr>
              <a:xfrm>
                <a:off x="11858760" y="392040"/>
                <a:ext cx="758880" cy="6964200"/>
              </a:xfrm>
              <a:prstGeom prst="rect">
                <a:avLst/>
              </a:prstGeom>
              <a:solidFill>
                <a:srgbClr val="eaeaea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Rectangle 32"/>
              <p:cNvSpPr/>
              <p:nvPr/>
            </p:nvSpPr>
            <p:spPr>
              <a:xfrm>
                <a:off x="13560480" y="379080"/>
                <a:ext cx="758880" cy="6980400"/>
              </a:xfrm>
              <a:prstGeom prst="rect">
                <a:avLst/>
              </a:prstGeom>
              <a:solidFill>
                <a:srgbClr val="eaeaea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Rectangle 33"/>
              <p:cNvSpPr/>
              <p:nvPr/>
            </p:nvSpPr>
            <p:spPr>
              <a:xfrm>
                <a:off x="15262200" y="392040"/>
                <a:ext cx="758880" cy="6967440"/>
              </a:xfrm>
              <a:prstGeom prst="rect">
                <a:avLst/>
              </a:prstGeom>
              <a:solidFill>
                <a:srgbClr val="eaeaea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55" name="Picture 13" descr=""/>
              <p:cNvPicPr/>
              <p:nvPr/>
            </p:nvPicPr>
            <p:blipFill>
              <a:blip r:embed="rId1"/>
              <a:srcRect l="5861" t="22003" r="51530" b="10835"/>
              <a:stretch/>
            </p:blipFill>
            <p:spPr>
              <a:xfrm>
                <a:off x="1046160" y="468000"/>
                <a:ext cx="5524560" cy="51040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6" name="Text Box 14"/>
              <p:cNvSpPr/>
              <p:nvPr/>
            </p:nvSpPr>
            <p:spPr>
              <a:xfrm rot="16200000">
                <a:off x="10464840" y="1292040"/>
                <a:ext cx="2195280" cy="10297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31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800" spc="-1" strike="noStrike">
                    <a:solidFill>
                      <a:srgbClr val="000000"/>
                    </a:solidFill>
                    <a:latin typeface="Arial"/>
                  </a:rPr>
                  <a:t>B. bacteriovorus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r">
                  <a:lnSpc>
                    <a:spcPct val="31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800" spc="-1" strike="noStrike">
                    <a:solidFill>
                      <a:srgbClr val="000000"/>
                    </a:solidFill>
                    <a:latin typeface="Arial"/>
                  </a:rPr>
                  <a:t>H. ochraceum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r">
                  <a:lnSpc>
                    <a:spcPct val="31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800" spc="-1" strike="noStrike">
                    <a:solidFill>
                      <a:srgbClr val="000000"/>
                    </a:solidFill>
                    <a:latin typeface="Arial"/>
                  </a:rPr>
                  <a:t>P. pacifica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r">
                  <a:lnSpc>
                    <a:spcPct val="31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800" spc="-1" strike="noStrike">
                    <a:solidFill>
                      <a:srgbClr val="000000"/>
                    </a:solidFill>
                    <a:latin typeface="Arial"/>
                  </a:rPr>
                  <a:t>So. Cellulosum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r">
                  <a:lnSpc>
                    <a:spcPct val="31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800" spc="-1" strike="noStrike">
                    <a:solidFill>
                      <a:srgbClr val="000000"/>
                    </a:solidFill>
                    <a:latin typeface="Arial"/>
                  </a:rPr>
                  <a:t>Ch. Apiculatus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r">
                  <a:lnSpc>
                    <a:spcPct val="31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800" spc="-1" strike="noStrike">
                    <a:solidFill>
                      <a:srgbClr val="000000"/>
                    </a:solidFill>
                    <a:latin typeface="Arial"/>
                  </a:rPr>
                  <a:t>St. aurantiaca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r">
                  <a:lnSpc>
                    <a:spcPct val="31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800" spc="-1" strike="noStrike">
                    <a:solidFill>
                      <a:srgbClr val="000000"/>
                    </a:solidFill>
                    <a:latin typeface="Arial"/>
                  </a:rPr>
                  <a:t>Co. coralloides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r">
                  <a:lnSpc>
                    <a:spcPct val="31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800" spc="-1" strike="noStrike">
                    <a:solidFill>
                      <a:srgbClr val="000000"/>
                    </a:solidFill>
                    <a:latin typeface="Arial"/>
                  </a:rPr>
                  <a:t>M. xanthus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r">
                  <a:lnSpc>
                    <a:spcPct val="31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800" spc="-1" strike="noStrike">
                    <a:solidFill>
                      <a:srgbClr val="000000"/>
                    </a:solidFill>
                    <a:latin typeface="Arial"/>
                  </a:rPr>
                  <a:t>M. fulvus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r">
                  <a:lnSpc>
                    <a:spcPct val="31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800" spc="-1" strike="noStrike">
                    <a:solidFill>
                      <a:srgbClr val="000000"/>
                    </a:solidFill>
                    <a:latin typeface="Arial"/>
                  </a:rPr>
                  <a:t>A. sp. Fw109-5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r">
                  <a:lnSpc>
                    <a:spcPct val="31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800" spc="-1" strike="noStrike">
                    <a:solidFill>
                      <a:srgbClr val="000000"/>
                    </a:solidFill>
                    <a:latin typeface="Arial"/>
                  </a:rPr>
                  <a:t>A. dehalo. 2CP-C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r">
                  <a:lnSpc>
                    <a:spcPct val="31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800" spc="-1" strike="noStrike">
                    <a:solidFill>
                      <a:srgbClr val="000000"/>
                    </a:solidFill>
                    <a:latin typeface="Arial"/>
                  </a:rPr>
                  <a:t>A. dehalo. 2CP-1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Text Box 15"/>
              <p:cNvSpPr/>
              <p:nvPr/>
            </p:nvSpPr>
            <p:spPr>
              <a:xfrm>
                <a:off x="6753240" y="407880"/>
                <a:ext cx="1046160" cy="4727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248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264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247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244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221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227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227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220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221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209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207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207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Text Box 16"/>
              <p:cNvSpPr/>
              <p:nvPr/>
            </p:nvSpPr>
            <p:spPr>
              <a:xfrm>
                <a:off x="7613640" y="407880"/>
                <a:ext cx="1314720" cy="4727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160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183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178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186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195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194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193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170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169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172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173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Text Box 17"/>
              <p:cNvSpPr/>
              <p:nvPr/>
            </p:nvSpPr>
            <p:spPr>
              <a:xfrm>
                <a:off x="8452080" y="407880"/>
                <a:ext cx="1314360" cy="4727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214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211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234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228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220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218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186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189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195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195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Text Box 18"/>
              <p:cNvSpPr/>
              <p:nvPr/>
            </p:nvSpPr>
            <p:spPr>
              <a:xfrm>
                <a:off x="9245880" y="407880"/>
                <a:ext cx="1314360" cy="4727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043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198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187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185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178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164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172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169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169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Text Box 19"/>
              <p:cNvSpPr/>
              <p:nvPr/>
            </p:nvSpPr>
            <p:spPr>
              <a:xfrm>
                <a:off x="10128240" y="407880"/>
                <a:ext cx="1314720" cy="4727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191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173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184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177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162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168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166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162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Text Box 20"/>
              <p:cNvSpPr/>
              <p:nvPr/>
            </p:nvSpPr>
            <p:spPr>
              <a:xfrm>
                <a:off x="10922040" y="407880"/>
                <a:ext cx="1314360" cy="4727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034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044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039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101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107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110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109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Text Box 21"/>
              <p:cNvSpPr/>
              <p:nvPr/>
            </p:nvSpPr>
            <p:spPr>
              <a:xfrm>
                <a:off x="11893680" y="407880"/>
                <a:ext cx="1314360" cy="4727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025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020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104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100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104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101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Text Box 22"/>
              <p:cNvSpPr/>
              <p:nvPr/>
            </p:nvSpPr>
            <p:spPr>
              <a:xfrm>
                <a:off x="12754080" y="407880"/>
                <a:ext cx="1314360" cy="4727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006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100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102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106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105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Text Box 23"/>
              <p:cNvSpPr/>
              <p:nvPr/>
            </p:nvSpPr>
            <p:spPr>
              <a:xfrm>
                <a:off x="13592160" y="407880"/>
                <a:ext cx="1314720" cy="4727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097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100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104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102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Text Box 24"/>
              <p:cNvSpPr/>
              <p:nvPr/>
            </p:nvSpPr>
            <p:spPr>
              <a:xfrm>
                <a:off x="14408280" y="407880"/>
                <a:ext cx="1314360" cy="4727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046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044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044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Text Box 25"/>
              <p:cNvSpPr/>
              <p:nvPr/>
            </p:nvSpPr>
            <p:spPr>
              <a:xfrm>
                <a:off x="15246360" y="407880"/>
                <a:ext cx="1314720" cy="4727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005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006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Text Box 26"/>
              <p:cNvSpPr/>
              <p:nvPr/>
            </p:nvSpPr>
            <p:spPr>
              <a:xfrm>
                <a:off x="16040160" y="407880"/>
                <a:ext cx="1314360" cy="4727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30000"/>
                  </a:lnSpc>
                  <a:tabLst>
                    <a:tab algn="l" pos="0"/>
                    <a:tab algn="l" pos="1154160"/>
                    <a:tab algn="l" pos="2308320"/>
                    <a:tab algn="l" pos="3462480"/>
                    <a:tab algn="l" pos="4616280"/>
                    <a:tab algn="l" pos="5770440"/>
                    <a:tab algn="l" pos="6924600"/>
                    <a:tab algn="l" pos="8078760"/>
                    <a:tab algn="l" pos="9232920"/>
                    <a:tab algn="l" pos="1038708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0.003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9" name="Oval 31"/>
            <p:cNvSpPr/>
            <p:nvPr/>
          </p:nvSpPr>
          <p:spPr>
            <a:xfrm>
              <a:off x="1282320" y="1453680"/>
              <a:ext cx="101520" cy="10800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pPr>
                <a:tabLst>
                  <a:tab algn="l" pos="0"/>
                  <a:tab algn="l" pos="1154160"/>
                  <a:tab algn="l" pos="2308320"/>
                  <a:tab algn="l" pos="3462480"/>
                  <a:tab algn="l" pos="4616280"/>
                  <a:tab algn="l" pos="5770440"/>
                  <a:tab algn="l" pos="6924600"/>
                  <a:tab algn="l" pos="8078760"/>
                  <a:tab algn="l" pos="9232920"/>
                  <a:tab algn="l" pos="10387080"/>
                </a:tabLst>
              </a:pPr>
              <a:endParaRPr b="0" lang="en-US" sz="23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0" name="TextBox 69"/>
          <p:cNvSpPr/>
          <p:nvPr/>
        </p:nvSpPr>
        <p:spPr>
          <a:xfrm>
            <a:off x="35640" y="7429680"/>
            <a:ext cx="2623680" cy="444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300" spc="-1" strike="noStrike">
                <a:solidFill>
                  <a:srgbClr val="000000"/>
                </a:solidFill>
                <a:latin typeface="Arial"/>
              </a:rPr>
              <a:t>Additional Figure 1</a:t>
            </a: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7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8-31T21:50:20Z</dcterms:created>
  <dc:creator>Dave Whitworth</dc:creator>
  <dc:description/>
  <dc:language>en-US</dc:language>
  <cp:lastModifiedBy>Dave</cp:lastModifiedBy>
  <dcterms:modified xsi:type="dcterms:W3CDTF">2015-04-28T09:52:53Z</dcterms:modified>
  <cp:revision>11</cp:revision>
  <dc:subject/>
  <dc:title>Slide 1</dc:title>
</cp:coreProperties>
</file>